
<file path=[Content_Types].xml><?xml version="1.0" encoding="utf-8"?>
<Types xmlns="http://schemas.openxmlformats.org/package/2006/content-types">
  <Default Extension="emf" ContentType="image/x-emf"/>
  <Default Extension="xls" ContentType="application/vnd.ms-excel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8" d="100"/>
          <a:sy n="128" d="100"/>
        </p:scale>
        <p:origin x="-117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3198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2717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6864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0398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8493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98940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310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6385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1228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333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1564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7600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Microsoft_Excel_97-2003_Worksheet1.xls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125760" y="116632"/>
            <a:ext cx="8892480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fontAlgn="base">
              <a:spcBef>
                <a:spcPct val="0"/>
              </a:spcBef>
              <a:spcAft>
                <a:spcPct val="0"/>
              </a:spcAft>
            </a:pPr>
            <a:r>
              <a:rPr kumimoji="0" lang="en-A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dditional file 7:</a:t>
            </a:r>
            <a:r>
              <a:rPr kumimoji="0" lang="en-A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Frequency distribution for salinity index value and qualitative rating (T (tolerant), MT-T (moderately tolerant to tolerant), MS-S (Moderately sensitive to sensitive), S (sensitive), HS (high sensitivity) for </a:t>
            </a:r>
            <a:r>
              <a:rPr kumimoji="0" lang="en-AU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Kaspa</a:t>
            </a:r>
            <a:r>
              <a:rPr kumimoji="0" lang="en-A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x Parafield RIL progeny following salinity treatment of 18 dsm-</a:t>
            </a:r>
            <a:r>
              <a:rPr kumimoji="0" lang="en-AU" sz="11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1</a:t>
            </a:r>
            <a:r>
              <a:rPr kumimoji="0" lang="en-A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 </a:t>
            </a:r>
            <a:endParaRPr kumimoji="0" lang="en-A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Objec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8541546"/>
              </p:ext>
            </p:extLst>
          </p:nvPr>
        </p:nvGraphicFramePr>
        <p:xfrm>
          <a:off x="899592" y="1268760"/>
          <a:ext cx="6552728" cy="4392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Chart" r:id="rId3" imgW="5943558" imgH="3086151" progId="Excel.Chart.8">
                  <p:embed/>
                </p:oleObj>
              </mc:Choice>
              <mc:Fallback>
                <p:oleObj name="Chart" r:id="rId3" imgW="5943558" imgH="3086151" progId="Excel.Chart.8">
                  <p:embed/>
                  <p:pic>
                    <p:nvPicPr>
                      <p:cNvPr id="0" name="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99592" y="1268760"/>
                        <a:ext cx="6552728" cy="4392488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0" y="35433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36465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5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Chart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MNA</dc:creator>
  <cp:lastModifiedBy>Shimna Sudheesh</cp:lastModifiedBy>
  <cp:revision>7</cp:revision>
  <dcterms:created xsi:type="dcterms:W3CDTF">2013-08-05T09:21:00Z</dcterms:created>
  <dcterms:modified xsi:type="dcterms:W3CDTF">2013-08-09T01:47:55Z</dcterms:modified>
</cp:coreProperties>
</file>